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>
      <p:cViewPr varScale="1">
        <p:scale>
          <a:sx n="92" d="100"/>
          <a:sy n="92" d="100"/>
        </p:scale>
        <p:origin x="498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122D64-5E5E-493C-9571-DC2343113D1C}" type="datetimeFigureOut">
              <a:rPr lang="en-ZA" smtClean="0"/>
              <a:t>2019/03/22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358A4E-D6D1-472D-BA5E-625BA60191DF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7576318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122D64-5E5E-493C-9571-DC2343113D1C}" type="datetimeFigureOut">
              <a:rPr lang="en-ZA" smtClean="0"/>
              <a:t>2019/03/22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358A4E-D6D1-472D-BA5E-625BA60191DF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5887919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122D64-5E5E-493C-9571-DC2343113D1C}" type="datetimeFigureOut">
              <a:rPr lang="en-ZA" smtClean="0"/>
              <a:t>2019/03/22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358A4E-D6D1-472D-BA5E-625BA60191DF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5273573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122D64-5E5E-493C-9571-DC2343113D1C}" type="datetimeFigureOut">
              <a:rPr lang="en-ZA" smtClean="0"/>
              <a:t>2019/03/22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358A4E-D6D1-472D-BA5E-625BA60191DF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3307315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122D64-5E5E-493C-9571-DC2343113D1C}" type="datetimeFigureOut">
              <a:rPr lang="en-ZA" smtClean="0"/>
              <a:t>2019/03/22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358A4E-D6D1-472D-BA5E-625BA60191DF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718240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122D64-5E5E-493C-9571-DC2343113D1C}" type="datetimeFigureOut">
              <a:rPr lang="en-ZA" smtClean="0"/>
              <a:t>2019/03/22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358A4E-D6D1-472D-BA5E-625BA60191DF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4048046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122D64-5E5E-493C-9571-DC2343113D1C}" type="datetimeFigureOut">
              <a:rPr lang="en-ZA" smtClean="0"/>
              <a:t>2019/03/22</a:t>
            </a:fld>
            <a:endParaRPr lang="en-Z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358A4E-D6D1-472D-BA5E-625BA60191DF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0582769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122D64-5E5E-493C-9571-DC2343113D1C}" type="datetimeFigureOut">
              <a:rPr lang="en-ZA" smtClean="0"/>
              <a:t>2019/03/22</a:t>
            </a:fld>
            <a:endParaRPr lang="en-Z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358A4E-D6D1-472D-BA5E-625BA60191DF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4860126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122D64-5E5E-493C-9571-DC2343113D1C}" type="datetimeFigureOut">
              <a:rPr lang="en-ZA" smtClean="0"/>
              <a:t>2019/03/22</a:t>
            </a:fld>
            <a:endParaRPr lang="en-Z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358A4E-D6D1-472D-BA5E-625BA60191DF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8976264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122D64-5E5E-493C-9571-DC2343113D1C}" type="datetimeFigureOut">
              <a:rPr lang="en-ZA" smtClean="0"/>
              <a:t>2019/03/22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358A4E-D6D1-472D-BA5E-625BA60191DF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5869765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Z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122D64-5E5E-493C-9571-DC2343113D1C}" type="datetimeFigureOut">
              <a:rPr lang="en-ZA" smtClean="0"/>
              <a:t>2019/03/22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358A4E-D6D1-472D-BA5E-625BA60191DF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6838428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122D64-5E5E-493C-9571-DC2343113D1C}" type="datetimeFigureOut">
              <a:rPr lang="en-ZA" smtClean="0"/>
              <a:t>2019/03/22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358A4E-D6D1-472D-BA5E-625BA60191DF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3484041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36936121"/>
              </p:ext>
            </p:extLst>
          </p:nvPr>
        </p:nvGraphicFramePr>
        <p:xfrm>
          <a:off x="587469" y="2070174"/>
          <a:ext cx="6029327" cy="4010040"/>
        </p:xfrm>
        <a:graphic>
          <a:graphicData uri="http://schemas.openxmlformats.org/drawingml/2006/table">
            <a:tbl>
              <a:tblPr firstRow="1" bandRow="1">
                <a:tableStyleId>{C083E6E3-FA7D-4D7B-A595-EF9225AFEA82}</a:tableStyleId>
              </a:tblPr>
              <a:tblGrid>
                <a:gridCol w="819201">
                  <a:extLst>
                    <a:ext uri="{9D8B030D-6E8A-4147-A177-3AD203B41FA5}">
                      <a16:colId xmlns="" xmlns:a16="http://schemas.microsoft.com/office/drawing/2014/main" val="3143261903"/>
                    </a:ext>
                  </a:extLst>
                </a:gridCol>
                <a:gridCol w="425985">
                  <a:extLst>
                    <a:ext uri="{9D8B030D-6E8A-4147-A177-3AD203B41FA5}">
                      <a16:colId xmlns="" xmlns:a16="http://schemas.microsoft.com/office/drawing/2014/main" val="622665106"/>
                    </a:ext>
                  </a:extLst>
                </a:gridCol>
                <a:gridCol w="688128">
                  <a:extLst>
                    <a:ext uri="{9D8B030D-6E8A-4147-A177-3AD203B41FA5}">
                      <a16:colId xmlns="" xmlns:a16="http://schemas.microsoft.com/office/drawing/2014/main" val="3830498814"/>
                    </a:ext>
                  </a:extLst>
                </a:gridCol>
                <a:gridCol w="1048577">
                  <a:extLst>
                    <a:ext uri="{9D8B030D-6E8A-4147-A177-3AD203B41FA5}">
                      <a16:colId xmlns="" xmlns:a16="http://schemas.microsoft.com/office/drawing/2014/main" val="2640019242"/>
                    </a:ext>
                  </a:extLst>
                </a:gridCol>
                <a:gridCol w="742742">
                  <a:extLst>
                    <a:ext uri="{9D8B030D-6E8A-4147-A177-3AD203B41FA5}">
                      <a16:colId xmlns="" xmlns:a16="http://schemas.microsoft.com/office/drawing/2014/main" val="2864964986"/>
                    </a:ext>
                  </a:extLst>
                </a:gridCol>
                <a:gridCol w="1004886">
                  <a:extLst>
                    <a:ext uri="{9D8B030D-6E8A-4147-A177-3AD203B41FA5}">
                      <a16:colId xmlns="" xmlns:a16="http://schemas.microsoft.com/office/drawing/2014/main" val="990915466"/>
                    </a:ext>
                  </a:extLst>
                </a:gridCol>
                <a:gridCol w="633515">
                  <a:extLst>
                    <a:ext uri="{9D8B030D-6E8A-4147-A177-3AD203B41FA5}">
                      <a16:colId xmlns="" xmlns:a16="http://schemas.microsoft.com/office/drawing/2014/main" val="1107338545"/>
                    </a:ext>
                  </a:extLst>
                </a:gridCol>
                <a:gridCol w="666293">
                  <a:extLst>
                    <a:ext uri="{9D8B030D-6E8A-4147-A177-3AD203B41FA5}">
                      <a16:colId xmlns="" xmlns:a16="http://schemas.microsoft.com/office/drawing/2014/main" val="2300159709"/>
                    </a:ext>
                  </a:extLst>
                </a:gridCol>
              </a:tblGrid>
              <a:tr h="42480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 dirty="0">
                          <a:effectLst/>
                        </a:rPr>
                        <a:t>storage temperature (°C)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 dirty="0">
                          <a:effectLst/>
                        </a:rPr>
                        <a:t>delay to 2nd test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 dirty="0">
                          <a:effectLst/>
                        </a:rPr>
                        <a:t>viral load 1 (copies/mL)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 dirty="0">
                          <a:effectLst/>
                        </a:rPr>
                        <a:t>viral load 1 (log copies /mL)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 dirty="0">
                          <a:effectLst/>
                        </a:rPr>
                        <a:t>viral load 2 (copies/mL)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 dirty="0">
                          <a:effectLst/>
                        </a:rPr>
                        <a:t>viral load 2 (log copies/mL)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 dirty="0">
                          <a:effectLst/>
                        </a:rPr>
                        <a:t>difference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collection tube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2740914813"/>
                  </a:ext>
                </a:extLst>
              </a:tr>
              <a:tr h="23469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20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72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31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 dirty="0">
                          <a:effectLst/>
                        </a:rPr>
                        <a:t>1.49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1491</a:t>
                      </a:r>
                      <a:endParaRPr lang="en-US" sz="1050" b="0" i="0" u="none" strike="noStrike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3.17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1.68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EDTA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2332577256"/>
                  </a:ext>
                </a:extLst>
              </a:tr>
              <a:tr h="23469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20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96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19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 dirty="0">
                          <a:effectLst/>
                        </a:rPr>
                        <a:t>1.28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 dirty="0">
                          <a:effectLst/>
                        </a:rPr>
                        <a:t>28162</a:t>
                      </a:r>
                      <a:endParaRPr lang="en-US" sz="1050" b="0" i="0" u="none" strike="noStrike" dirty="0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 dirty="0">
                          <a:effectLst/>
                        </a:rPr>
                        <a:t>4.45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3.17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EDTA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1251491535"/>
                  </a:ext>
                </a:extLst>
              </a:tr>
              <a:tr h="23469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30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168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1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0.00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 dirty="0">
                          <a:effectLst/>
                        </a:rPr>
                        <a:t>1185</a:t>
                      </a:r>
                      <a:endParaRPr lang="en-US" sz="1050" b="0" i="0" u="none" strike="noStrike" dirty="0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3.07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3.07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EDTA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446833464"/>
                  </a:ext>
                </a:extLst>
              </a:tr>
              <a:tr h="23469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20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72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145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2.16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 dirty="0">
                          <a:effectLst/>
                        </a:rPr>
                        <a:t>1000</a:t>
                      </a:r>
                      <a:endParaRPr lang="en-US" sz="1050" b="0" i="0" u="none" strike="noStrike" dirty="0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3.00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0.84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EDTA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4026820566"/>
                  </a:ext>
                </a:extLst>
              </a:tr>
              <a:tr h="23469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20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72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751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2.88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 dirty="0">
                          <a:effectLst/>
                        </a:rPr>
                        <a:t>70086</a:t>
                      </a:r>
                      <a:endParaRPr lang="en-US" sz="1050" b="0" i="0" u="none" strike="noStrike" dirty="0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4.85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1.97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EDTA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1105830645"/>
                  </a:ext>
                </a:extLst>
              </a:tr>
              <a:tr h="23469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30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 dirty="0">
                          <a:effectLst/>
                        </a:rPr>
                        <a:t>96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265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2.42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 dirty="0">
                          <a:effectLst/>
                        </a:rPr>
                        <a:t>1600</a:t>
                      </a:r>
                      <a:endParaRPr lang="en-US" sz="105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3.20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0.78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EDTA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3258830336"/>
                  </a:ext>
                </a:extLst>
              </a:tr>
              <a:tr h="23469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30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168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374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2.57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 dirty="0">
                          <a:effectLst/>
                        </a:rPr>
                        <a:t>2576</a:t>
                      </a:r>
                      <a:endParaRPr lang="en-US" sz="1050" b="0" i="0" u="none" strike="noStrike" dirty="0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3.41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0.84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EDTA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1835444861"/>
                  </a:ext>
                </a:extLst>
              </a:tr>
              <a:tr h="23469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4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72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2140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3.33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 dirty="0">
                          <a:effectLst/>
                        </a:rPr>
                        <a:t>567</a:t>
                      </a:r>
                      <a:endParaRPr lang="en-US" sz="1050" b="0" i="0" u="none" strike="noStrike" dirty="0">
                        <a:solidFill>
                          <a:srgbClr val="00B05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2.75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-0.58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EDTA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3074918419"/>
                  </a:ext>
                </a:extLst>
              </a:tr>
              <a:tr h="23469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4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168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1997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 dirty="0">
                          <a:effectLst/>
                        </a:rPr>
                        <a:t>3.30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 dirty="0">
                          <a:effectLst/>
                        </a:rPr>
                        <a:t>552</a:t>
                      </a:r>
                      <a:endParaRPr lang="en-US" sz="1050" b="0" i="0" u="none" strike="noStrike" dirty="0">
                        <a:solidFill>
                          <a:srgbClr val="70AD47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2.74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-0.56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PPT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604520118"/>
                  </a:ext>
                </a:extLst>
              </a:tr>
              <a:tr h="23469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4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72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2505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 dirty="0">
                          <a:effectLst/>
                        </a:rPr>
                        <a:t>3.40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 dirty="0">
                          <a:effectLst/>
                        </a:rPr>
                        <a:t>500</a:t>
                      </a:r>
                      <a:endParaRPr lang="en-US" sz="1050" b="0" i="0" u="none" strike="noStrike" dirty="0">
                        <a:solidFill>
                          <a:srgbClr val="70AD47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2.70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-0.70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PPT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4062065432"/>
                  </a:ext>
                </a:extLst>
              </a:tr>
              <a:tr h="23469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4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96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2940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3.47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 dirty="0">
                          <a:effectLst/>
                        </a:rPr>
                        <a:t>755</a:t>
                      </a:r>
                      <a:endParaRPr lang="en-US" sz="1050" b="0" i="0" u="none" strike="noStrike" dirty="0">
                        <a:solidFill>
                          <a:srgbClr val="70AD47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2.88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-0.59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PPT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605670327"/>
                  </a:ext>
                </a:extLst>
              </a:tr>
              <a:tr h="23469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4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96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147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2.17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 dirty="0">
                          <a:effectLst/>
                        </a:rPr>
                        <a:t>1034</a:t>
                      </a:r>
                      <a:endParaRPr lang="en-US" sz="1050" b="0" i="0" u="none" strike="noStrike" dirty="0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3.01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0.85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PPT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1316186888"/>
                  </a:ext>
                </a:extLst>
              </a:tr>
              <a:tr h="23469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20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72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280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2.45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 dirty="0">
                          <a:effectLst/>
                        </a:rPr>
                        <a:t>1152</a:t>
                      </a:r>
                      <a:endParaRPr lang="en-US" sz="1050" b="0" i="0" u="none" strike="noStrike" dirty="0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3.06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0.61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PPT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4215087806"/>
                  </a:ext>
                </a:extLst>
              </a:tr>
              <a:tr h="23469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20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72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587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2.77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4641</a:t>
                      </a:r>
                      <a:endParaRPr lang="en-US" sz="1050" b="0" i="0" u="none" strike="noStrike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 dirty="0">
                          <a:effectLst/>
                        </a:rPr>
                        <a:t>3.67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 dirty="0">
                          <a:effectLst/>
                        </a:rPr>
                        <a:t>0.90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PPT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4081936734"/>
                  </a:ext>
                </a:extLst>
              </a:tr>
              <a:tr h="234697"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 dirty="0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4070037906"/>
                  </a:ext>
                </a:extLst>
              </a:tr>
            </a:tbl>
          </a:graphicData>
        </a:graphic>
      </p:graphicFrame>
      <p:sp>
        <p:nvSpPr>
          <p:cNvPr id="5" name="Rectangle 4"/>
          <p:cNvSpPr/>
          <p:nvPr/>
        </p:nvSpPr>
        <p:spPr>
          <a:xfrm>
            <a:off x="476249" y="452734"/>
            <a:ext cx="8482013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ZA" b="1" dirty="0" smtClean="0"/>
              <a:t>S2 Table</a:t>
            </a:r>
            <a:endParaRPr lang="en-ZA" b="1" dirty="0"/>
          </a:p>
          <a:p>
            <a:r>
              <a:rPr lang="en-ZA" b="1" dirty="0" smtClean="0"/>
              <a:t>Instances </a:t>
            </a:r>
            <a:r>
              <a:rPr lang="en-ZA" b="1" dirty="0"/>
              <a:t>where the difference between tests 1and 2 altered patient status </a:t>
            </a:r>
            <a:endParaRPr lang="en-ZA" b="1" dirty="0" smtClean="0"/>
          </a:p>
          <a:p>
            <a:r>
              <a:rPr lang="en-ZA" b="1" dirty="0" smtClean="0"/>
              <a:t>according </a:t>
            </a:r>
            <a:r>
              <a:rPr lang="en-ZA" b="1" dirty="0"/>
              <a:t>to WHO guidelines</a:t>
            </a:r>
            <a:endParaRPr lang="en-US" b="1" dirty="0"/>
          </a:p>
        </p:txBody>
      </p:sp>
      <p:sp>
        <p:nvSpPr>
          <p:cNvPr id="6" name="TextBox 5"/>
          <p:cNvSpPr txBox="1"/>
          <p:nvPr/>
        </p:nvSpPr>
        <p:spPr>
          <a:xfrm>
            <a:off x="587469" y="1492286"/>
            <a:ext cx="60465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200" dirty="0" smtClean="0"/>
              <a:t>N=14</a:t>
            </a:r>
          </a:p>
          <a:p>
            <a:r>
              <a:rPr lang="en-ZA" sz="1200" dirty="0" smtClean="0"/>
              <a:t>1.17 %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18268693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76</Words>
  <Application>Microsoft Office PowerPoint</Application>
  <PresentationFormat>Widescreen</PresentationFormat>
  <Paragraphs>12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of Cape Town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indows User</dc:creator>
  <cp:lastModifiedBy>Windows User</cp:lastModifiedBy>
  <cp:revision>1</cp:revision>
  <dcterms:created xsi:type="dcterms:W3CDTF">2019-03-22T09:13:32Z</dcterms:created>
  <dcterms:modified xsi:type="dcterms:W3CDTF">2019-03-22T09:14:06Z</dcterms:modified>
</cp:coreProperties>
</file>